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48"/>
  </p:normalViewPr>
  <p:slideViewPr>
    <p:cSldViewPr snapToGrid="0" snapToObjects="1">
      <p:cViewPr varScale="1">
        <p:scale>
          <a:sx n="117" d="100"/>
          <a:sy n="117" d="100"/>
        </p:scale>
        <p:origin x="264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E26A6B3-53DB-99A8-F0F7-D2ECB772A9E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2DAE920C-AEC3-90B1-2FA1-FA3CDEF7C42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B80EC2D-ADC9-3193-593E-EAE421DD11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19F3E0-ADAA-044A-BF07-94AD4989BE54}" type="datetimeFigureOut">
              <a:rPr kumimoji="1" lang="ja-JP" altLang="en-US" smtClean="0"/>
              <a:t>2022/4/1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2C56794-E353-05BA-40C7-864238264D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489641B-89A7-CBC1-257A-C4AD580B3F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F67FBD-3DBB-5943-9D9D-B540FAB4AF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758673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5BCBACF-DA3E-9DEB-B995-F381C36BD0C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0D6647C1-B271-72A7-C6E9-A8BDE5A7D2A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CC15D90-EC5E-5E6C-2296-490DA47643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19F3E0-ADAA-044A-BF07-94AD4989BE54}" type="datetimeFigureOut">
              <a:rPr kumimoji="1" lang="ja-JP" altLang="en-US" smtClean="0"/>
              <a:t>2022/4/1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AA13F89-7CFB-AE10-3372-5B819180C4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ADAE785-5A2B-713D-FC1B-32F44CE281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F67FBD-3DBB-5943-9D9D-B540FAB4AF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209822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BD4E36A2-DA28-7E33-50DC-93C142B80E9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EA3E40C5-CF28-02B0-A1D0-32CC21C9558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4E27915-0E8A-02FD-CD8F-65830818D7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19F3E0-ADAA-044A-BF07-94AD4989BE54}" type="datetimeFigureOut">
              <a:rPr kumimoji="1" lang="ja-JP" altLang="en-US" smtClean="0"/>
              <a:t>2022/4/1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A4ED33C-46B9-43D7-8506-281E377599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0BF5CC3-0124-6C0E-3090-323E8B21ED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F67FBD-3DBB-5943-9D9D-B540FAB4AF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660516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981DCCF-06CE-28B3-F8B9-7666DC04FAC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B406704E-05C8-2F8E-A82C-E953C3D5F90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9A833BD-0FF6-30B8-2370-3DDA85178B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19F3E0-ADAA-044A-BF07-94AD4989BE54}" type="datetimeFigureOut">
              <a:rPr kumimoji="1" lang="ja-JP" altLang="en-US" smtClean="0"/>
              <a:t>2022/4/1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9F73B24-2B17-7CCD-DBF0-7AAF7E957E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282B383-B871-DCC6-0A6D-6940405CAE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F67FBD-3DBB-5943-9D9D-B540FAB4AF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144225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88DAC4C-EB6F-A6F5-22AA-4DB48734CAE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5FE239DD-044E-B67A-A60F-0885B89221C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600EFFC-3E64-3FA7-FEAA-2964E2D24C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19F3E0-ADAA-044A-BF07-94AD4989BE54}" type="datetimeFigureOut">
              <a:rPr kumimoji="1" lang="ja-JP" altLang="en-US" smtClean="0"/>
              <a:t>2022/4/1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35DA529-DE54-DF70-86B0-B3AE386657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9BA990F-0397-90FB-924D-E529897886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F67FBD-3DBB-5943-9D9D-B540FAB4AF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212575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518BE72-E46E-F4CA-C59D-58034B81160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968DEF7E-586B-0BA5-A7B7-BD2CCCBD4D8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AEBF90B1-A3C0-F6D6-2709-2CD1AC6A3CF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E6378EB6-6F59-FB87-5EA0-BEC585ADE5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19F3E0-ADAA-044A-BF07-94AD4989BE54}" type="datetimeFigureOut">
              <a:rPr kumimoji="1" lang="ja-JP" altLang="en-US" smtClean="0"/>
              <a:t>2022/4/1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25FFB763-7AA7-4191-428A-2860B31D47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70DAF1A7-C640-2E29-E925-6CEAD07EB2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F67FBD-3DBB-5943-9D9D-B540FAB4AF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731384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30305B6-E26B-9498-0AA7-F7C469AD59D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B49498D6-5404-2B92-AF02-DA195378844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21D1F773-4BD6-01CD-755E-3691F394CE1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712E144B-047D-DFF2-8FDC-4BAAF7FA188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074EFF05-556F-CB0C-52E0-0A7FE4C9924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441ED869-CE31-781B-FD8C-E05AB3F2AB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19F3E0-ADAA-044A-BF07-94AD4989BE54}" type="datetimeFigureOut">
              <a:rPr kumimoji="1" lang="ja-JP" altLang="en-US" smtClean="0"/>
              <a:t>2022/4/17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A59BE30C-5335-9F1C-6B59-3EAC604060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29FF06B6-C976-C055-EA4D-0BADBA0B7C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F67FBD-3DBB-5943-9D9D-B540FAB4AF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925657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521C236-3384-10A6-53AA-9B817B8E644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A4C984A9-E4E8-FA24-BEF5-E6806E4F83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19F3E0-ADAA-044A-BF07-94AD4989BE54}" type="datetimeFigureOut">
              <a:rPr kumimoji="1" lang="ja-JP" altLang="en-US" smtClean="0"/>
              <a:t>2022/4/17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5D7B7868-366F-858B-AF13-FC440500D6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77AE5E4E-6023-8923-34E6-3E5ADA94DC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F67FBD-3DBB-5943-9D9D-B540FAB4AF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714826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DF648178-9172-614B-0461-1246C9FE4A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19F3E0-ADAA-044A-BF07-94AD4989BE54}" type="datetimeFigureOut">
              <a:rPr kumimoji="1" lang="ja-JP" altLang="en-US" smtClean="0"/>
              <a:t>2022/4/17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5322F2A1-C669-534F-21A0-EDDFCF51EE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5A3054AA-435D-02CB-6B79-CEB79FBC9F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F67FBD-3DBB-5943-9D9D-B540FAB4AF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331962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3DC66D2-D5A6-BACB-CD8C-85C568D452F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AAE21EF9-A55E-F4AC-34AA-C8379310FF6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E80A450D-3656-90CE-D4C6-9346C827E83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3F7FFBAB-EE83-33E2-059C-B41E360531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19F3E0-ADAA-044A-BF07-94AD4989BE54}" type="datetimeFigureOut">
              <a:rPr kumimoji="1" lang="ja-JP" altLang="en-US" smtClean="0"/>
              <a:t>2022/4/1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AE1A6FF4-2BE5-1935-20B9-C5D2542BD1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4F351E7C-8214-785B-E29C-BF15003C8A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F67FBD-3DBB-5943-9D9D-B540FAB4AF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008604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027A21E-C248-6373-F66A-9A1F73F7BE1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2344B739-E54E-5588-89B6-F5E346551F1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36085C20-368D-0040-DB76-5E71184BC6F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DC425EA7-69BE-F829-0FB4-D89566DF00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19F3E0-ADAA-044A-BF07-94AD4989BE54}" type="datetimeFigureOut">
              <a:rPr kumimoji="1" lang="ja-JP" altLang="en-US" smtClean="0"/>
              <a:t>2022/4/1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8D17009C-A979-A9FC-A420-25C2A58210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551B126A-C6EC-7754-5E64-A9D25A8AB1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F67FBD-3DBB-5943-9D9D-B540FAB4AF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056605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009491AB-6508-940A-65C8-88F1F20998E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85C4AFFF-F909-A383-F80D-7B1E9EE143A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3E9CAD9-250F-2110-7441-AFF80BFA80E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19F3E0-ADAA-044A-BF07-94AD4989BE54}" type="datetimeFigureOut">
              <a:rPr kumimoji="1" lang="ja-JP" altLang="en-US" smtClean="0"/>
              <a:t>2022/4/1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75982BD-F924-C259-FA58-F22BA68A533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682CDC4-B4E8-4AF2-E3AE-46B93D6DB76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F67FBD-3DBB-5943-9D9D-B540FAB4AF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230710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>
            <a:extLst>
              <a:ext uri="{FF2B5EF4-FFF2-40B4-BE49-F238E27FC236}">
                <a16:creationId xmlns:a16="http://schemas.microsoft.com/office/drawing/2014/main" id="{A9223601-CE36-623B-C77E-8AAB8458861C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30982" b="21418"/>
          <a:stretch/>
        </p:blipFill>
        <p:spPr>
          <a:xfrm>
            <a:off x="558797" y="1372471"/>
            <a:ext cx="11074405" cy="3308717"/>
          </a:xfrm>
          <a:prstGeom prst="rect">
            <a:avLst/>
          </a:prstGeom>
        </p:spPr>
      </p:pic>
      <p:pic>
        <p:nvPicPr>
          <p:cNvPr id="6" name="図 5">
            <a:extLst>
              <a:ext uri="{FF2B5EF4-FFF2-40B4-BE49-F238E27FC236}">
                <a16:creationId xmlns:a16="http://schemas.microsoft.com/office/drawing/2014/main" id="{A54BF1A3-986D-2E5B-9312-C3D0CF7027FD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80282"/>
          <a:stretch/>
        </p:blipFill>
        <p:spPr>
          <a:xfrm>
            <a:off x="539762" y="4974559"/>
            <a:ext cx="10933781" cy="565728"/>
          </a:xfrm>
          <a:prstGeom prst="rect">
            <a:avLst/>
          </a:prstGeom>
        </p:spPr>
      </p:pic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D4FD18B8-54EB-B953-FC5A-E809CCCB4E61}"/>
              </a:ext>
            </a:extLst>
          </p:cNvPr>
          <p:cNvSpPr/>
          <p:nvPr/>
        </p:nvSpPr>
        <p:spPr>
          <a:xfrm>
            <a:off x="1273627" y="5927160"/>
            <a:ext cx="9900745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ja-JP" altLang="ja-JP" sz="1600" kern="10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. S</a:t>
            </a:r>
            <a:r>
              <a:rPr lang="en-US" altLang="ja-JP" sz="1600" kern="1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3  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omatic alterations of driver genes in glioblastoma. Driver gene mutations and copy number alterations were generated and visualized using </a:t>
            </a:r>
            <a:r>
              <a:rPr lang="en-US" altLang="ja-JP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ncoPrinter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which is included in the </a:t>
            </a:r>
            <a:r>
              <a:rPr lang="en-US" altLang="ja-JP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BioPortal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or Cancer Genomics software suite.</a:t>
            </a:r>
            <a:endParaRPr lang="ja-JP" altLang="ja-JP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ja-JP" altLang="ja-JP" sz="1600" kern="100">
              <a:latin typeface="Times New Roman" panose="02020603050405020304" pitchFamily="18" charset="0"/>
              <a:ea typeface="ＭＳ Ｐゴシック" panose="020B0600070205080204" pitchFamily="34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526544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37</Words>
  <Application>Microsoft Macintosh PowerPoint</Application>
  <PresentationFormat>ワイド画面</PresentationFormat>
  <Paragraphs>1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比嘉　那優大</dc:creator>
  <cp:lastModifiedBy>比嘉　那優大</cp:lastModifiedBy>
  <cp:revision>2</cp:revision>
  <dcterms:created xsi:type="dcterms:W3CDTF">2022-04-16T04:08:52Z</dcterms:created>
  <dcterms:modified xsi:type="dcterms:W3CDTF">2022-04-17T07:23:27Z</dcterms:modified>
</cp:coreProperties>
</file>